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73" r:id="rId2"/>
    <p:sldId id="274" r:id="rId3"/>
    <p:sldId id="275" r:id="rId4"/>
    <p:sldId id="272" r:id="rId5"/>
    <p:sldId id="27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A7C8041-2802-4F56-7A83-436CE0451A61}" name="Palmer, Andre" initials="AP" userId="S::palmer.351@osu.edu::06746ccc-d891-40c9-af11-7935635b117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74"/>
    <p:restoredTop sz="94633"/>
  </p:normalViewPr>
  <p:slideViewPr>
    <p:cSldViewPr snapToGrid="0">
      <p:cViewPr varScale="1">
        <p:scale>
          <a:sx n="96" d="100"/>
          <a:sy n="96" d="100"/>
        </p:scale>
        <p:origin x="10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F91874-38A9-2E4C-A704-2459851983AA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EA08FB-1703-A349-A4DE-7A604F5177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60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925EF-2D11-0B4C-702A-7970F23698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30BD3D-8C9A-F3A5-B586-44C0D07EC8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F2AFDF-C819-82AD-3EA4-3BF19DEFA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8EFBE-51F0-45E3-8B77-A3717473C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11B573-3822-5B3D-1C89-CF95D7B55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225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CDAE1-2516-60FF-C203-D04CE0F34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CFDBB6-DB84-2C91-2DF0-02B32CEBC9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B59B59-6EBE-97E1-2C1A-1453C41A5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789876-4B9D-0488-2682-9BC641C88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27FE81-0FDE-40EF-9267-6630D2151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27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0440A2-E131-6571-B056-E4A550230B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F4CA2D-5200-1C0E-0E86-518E37F97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1ADAC0-A92B-088D-042D-1B564866C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C21F44-7003-1C86-8D3E-E83CA2706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F4B83-77A3-B00B-29BE-4B9281016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911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CCB01-470C-B010-0883-E3C85B72F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87C12-FC8C-B439-9642-21B422C39B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08418A-E45D-13D9-2563-F9F643FFD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8C187A-C72D-FC6B-4EE1-15B3FE931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C58FC-4217-734E-7986-1D3E8DCAB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576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BA806-F1E6-0977-4D43-0870DE12E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8BC66D-3226-06E9-2081-42C5FD74DC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6433FA-E52C-F0C3-A9AE-DEB5826A8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AE1BE-C11E-1E62-DC3F-55154261D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A0E205-4BC7-542A-323D-77AE0AF4F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64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6B770-D841-838B-976A-94CFC905C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467ABE-A3C5-CCFE-840B-8F622A49E1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3B56F2-01DF-4FEF-3696-58205D72E0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7DB23A-9AB1-E047-9C56-0B35D81EE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7705B-27D7-361E-7F43-52BB25E10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0C3A9A-73FB-0657-C8B7-6E553D18D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466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E0117-6684-9A38-503C-D8F47C723B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36FCA8-6320-7FC7-7ED0-CDA71042A2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572317-BED4-8D2F-65A7-3399852CA2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64257A-DC8F-AEE9-C88E-00C95BA988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AFEF42-741C-4E15-2BB9-E5C8BA63D0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D81C403-00C9-6F35-5E95-DD386A6F7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C12646-38C9-229C-6351-2886134F8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2172A5-70AF-332F-0EB4-EB33ACCB4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578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4E1D2-86E4-20EE-8020-358D7EF33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746108-0D85-D109-ED34-C955BB0D5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216CCD-A0D0-115F-C99D-C957BFA73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E5C73D-D1F4-E220-6126-0983CC519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575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A3FDC2-AD70-CE39-789D-A1F3728D6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011C57-2942-B456-0C06-C5AE346E0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DBC0BD-D136-CF5B-AA8E-E110DEFB26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211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CAFD1-4A53-BF76-2ADB-F63E3AA7C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76209-D151-23E4-EDF6-164A79E8B4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3BE35F-013E-9535-58E3-96A7E19EB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65F0AE-7279-0E25-E142-9ED603579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CB7B76-F8A5-EDFE-8272-EFD7FD5EE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A9495-EE1E-44CF-2A00-8F4B8B9A3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232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AD8CA-94CD-1DAA-2B7E-A9795D286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4E8060-EE9C-38AF-D17A-2938862E63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C6F588-E3C2-D2C2-9981-BFBB3AC8F1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D083FE-2FBA-4670-5C35-B6184993C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531921-3765-A346-C09B-76B21BD66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B3E49B-D00F-00E9-9564-BFDCAC582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562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41359D-1CAE-49BF-1A60-4C62017FB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A168D3-9013-5308-D6CB-7DEF3E5C89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4649D-055C-8DDE-6BB7-587B91A289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8EBC84-EFC7-F844-B91E-E93EB1A837F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7C001F-C4D1-3050-684C-3678D80532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7F7C6A-54BA-059E-43FC-EB873C00F1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DD520C-B0B4-BA42-A21B-DBF653842C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536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E886BD-59C4-737E-82F0-96B0FC5875F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DC2FA3E-FF29-E507-B03E-A0782E40EA1D}"/>
              </a:ext>
            </a:extLst>
          </p:cNvPr>
          <p:cNvSpPr txBox="1"/>
          <p:nvPr/>
        </p:nvSpPr>
        <p:spPr>
          <a:xfrm>
            <a:off x="139861" y="4912360"/>
            <a:ext cx="1191227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t"/>
            <a:r>
              <a:rPr lang="en-US" b="1" dirty="0">
                <a:latin typeface="Aptos" panose="020B0004020202020204" pitchFamily="34" charset="0"/>
              </a:rPr>
              <a:t>Figure S1: Absolute Baseline Glomerular Filtration Rate</a:t>
            </a:r>
            <a:r>
              <a:rPr lang="en-US" b="1" dirty="0"/>
              <a:t>.</a:t>
            </a:r>
            <a:r>
              <a:rPr lang="en-US" dirty="0"/>
              <a:t> </a:t>
            </a:r>
            <a:r>
              <a:rPr lang="en-US" b="1" dirty="0"/>
              <a:t>Plasma hemoglobin concentrations following exchange transfusion.</a:t>
            </a:r>
            <a:br>
              <a:rPr lang="en-US" dirty="0"/>
            </a:br>
            <a:r>
              <a:rPr lang="en-US" dirty="0"/>
              <a:t>Plasma Hb concentrations were measured 2 hours, 4 hours, and 24 hours after Hb infusion to confirm equivalent exposure across experimental groups. No significant differences in circulating plasma Hb were observed between males, estrous-phase females, and non-estrous-phase females, confirming consistent Hb exposure across groups (one-way ANOVA, p &gt; 0.05). </a:t>
            </a:r>
            <a:r>
              <a:rPr lang="en-US" dirty="0">
                <a:solidFill>
                  <a:srgbClr val="000000"/>
                </a:solidFill>
                <a:latin typeface="-webkit-standard"/>
              </a:rPr>
              <a:t>Statistical significance against the baseline is indicated by †.</a:t>
            </a:r>
            <a:endParaRPr lang="en-US" b="1" dirty="0">
              <a:latin typeface="Aptos" panose="020B00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A6359CE-BB4D-1977-089F-75A6E67413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3310" y="1188264"/>
            <a:ext cx="7805379" cy="3347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6467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F93A16-9689-5A9E-540C-79DE46C59C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E1B51BA-70DB-0AA1-1140-B8BDAD05F987}"/>
              </a:ext>
            </a:extLst>
          </p:cNvPr>
          <p:cNvSpPr txBox="1"/>
          <p:nvPr/>
        </p:nvSpPr>
        <p:spPr>
          <a:xfrm>
            <a:off x="139861" y="4912360"/>
            <a:ext cx="119122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t"/>
            <a:r>
              <a:rPr lang="en-US" b="1" dirty="0">
                <a:latin typeface="Aptos" panose="020B0004020202020204" pitchFamily="34" charset="0"/>
              </a:rPr>
              <a:t>Figure S2: Absolute Baseline Glomerular Filtration Rate</a:t>
            </a:r>
            <a:r>
              <a:rPr lang="en-US" b="1" dirty="0"/>
              <a:t>.</a:t>
            </a:r>
            <a:r>
              <a:rPr lang="en-US" dirty="0"/>
              <a:t> Baseline glomerular filtration rate (GFR) in control male, estrous-phase female, and non-estrous-phase female rats. Absolute GFR values measured before hemoglobin exposure show no significant differences among groups (one-way ANOVA, p &gt; 0.05). These data support normalization of subsequent GFR measurements to each group’s own baseline.</a:t>
            </a:r>
            <a:r>
              <a:rPr lang="en-US" dirty="0">
                <a:solidFill>
                  <a:srgbClr val="000000"/>
                </a:solidFill>
                <a:latin typeface="Aptos" panose="020B0004020202020204" pitchFamily="34" charset="0"/>
              </a:rPr>
              <a:t> </a:t>
            </a:r>
            <a:endParaRPr lang="en-US" b="1" dirty="0">
              <a:latin typeface="Aptos" panose="020B00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34F4A6-7CFD-FB38-1681-49880C7B09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5140" y="699591"/>
            <a:ext cx="2734310" cy="38219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06138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A8969B-9BB0-2185-E378-BCD010877D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6C8D42A-0147-9932-D341-5BDE3C6AF295}"/>
              </a:ext>
            </a:extLst>
          </p:cNvPr>
          <p:cNvSpPr txBox="1"/>
          <p:nvPr/>
        </p:nvSpPr>
        <p:spPr>
          <a:xfrm>
            <a:off x="112542" y="4546600"/>
            <a:ext cx="1191227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t"/>
            <a:r>
              <a:rPr lang="en-US" b="1" dirty="0">
                <a:latin typeface="Aptos" panose="020B0004020202020204" pitchFamily="34" charset="0"/>
              </a:rPr>
              <a:t>Figure S3: </a:t>
            </a:r>
            <a:r>
              <a:rPr lang="en-US" b="1" dirty="0"/>
              <a:t>Correlation between GFR and kidney injury biomarkers across all experimental groups.</a:t>
            </a:r>
            <a:br>
              <a:rPr lang="en-US" dirty="0"/>
            </a:br>
            <a:r>
              <a:rPr lang="en-US" dirty="0"/>
              <a:t>Scatter plots illustrate the relationship between glomerular filtration rate (GFR) and some representative markers (A) KIM-1, (B) IL-18</a:t>
            </a:r>
            <a:r>
              <a:rPr lang="el-GR" dirty="0"/>
              <a:t>, </a:t>
            </a:r>
            <a:r>
              <a:rPr lang="en-US" dirty="0"/>
              <a:t>and (C) Creatinine levels. Linear regression lines are included in each plot. Pearson’s correlation coefficients (r) indicate a strong negative correlation for KIM-1 (r = -0.7), IL-18</a:t>
            </a:r>
            <a:r>
              <a:rPr lang="el-GR" dirty="0"/>
              <a:t> (</a:t>
            </a:r>
            <a:r>
              <a:rPr lang="en-US" dirty="0"/>
              <a:t>r = -0.7), and Creatinine (r = -0.7). The coefficient of determination (R²) values for the linear regression were 0.6, 0.5, and 0.5 for KIM-1, IL-18</a:t>
            </a:r>
            <a:r>
              <a:rPr lang="el-GR" dirty="0"/>
              <a:t>, </a:t>
            </a:r>
            <a:r>
              <a:rPr lang="en-US" dirty="0"/>
              <a:t>and Creatinine, respectively, indicating the proportion of variance in biomarker levels explained by GFR. All correlations were statistically significant (p &lt; 0.05).</a:t>
            </a:r>
            <a:endParaRPr lang="en-US" b="1" dirty="0">
              <a:latin typeface="Aptos" panose="020B00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F856B33-DF81-3865-7878-BB1E44DED2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686" y="1691640"/>
            <a:ext cx="10494214" cy="2472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9354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0E0AED2-B663-F08B-B29E-7F0C6342E37C}"/>
              </a:ext>
            </a:extLst>
          </p:cNvPr>
          <p:cNvSpPr txBox="1"/>
          <p:nvPr/>
        </p:nvSpPr>
        <p:spPr>
          <a:xfrm>
            <a:off x="139861" y="4912360"/>
            <a:ext cx="1191227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t"/>
            <a:r>
              <a:rPr lang="en-US" b="1" dirty="0">
                <a:latin typeface="Aptos" panose="020B0004020202020204" pitchFamily="34" charset="0"/>
              </a:rPr>
              <a:t>Figure S4: Systemic Inflammatory and Injury Biomarkers</a:t>
            </a:r>
            <a:r>
              <a:rPr lang="en-US" dirty="0">
                <a:solidFill>
                  <a:srgbClr val="000000"/>
                </a:solidFill>
                <a:latin typeface="Aptos" panose="020B0004020202020204" pitchFamily="34" charset="0"/>
              </a:rPr>
              <a:t>. Plasma levels of inflammatory cytokines A) IL-6 and B) IL-10, C) renal injury marker (BUN), and D) stress response enzyme (HO-1) were quantified in Hb-treated males and females stratified by estrous cycle phase. While all groups demonstrated elevated markers consistent with Hb-induced systemic toxicity versus their control, estrous females exhibited a modest trend toward reduced IL-6, IL-10, BUN, and HO-1 levels compared to non-estrous females and males. 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Statistical significance </a:t>
            </a:r>
            <a:r>
              <a:rPr lang="en-US" dirty="0">
                <a:solidFill>
                  <a:srgbClr val="000000"/>
                </a:solidFill>
                <a:latin typeface="-webkit-standard"/>
              </a:rPr>
              <a:t>compared 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to the control group is indicated by † .</a:t>
            </a:r>
            <a:endParaRPr lang="en-US" b="1" dirty="0">
              <a:latin typeface="Aptos" panose="020B00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FA37ADD-CF45-9AC1-E5E0-8461926EE5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6763" y="765810"/>
            <a:ext cx="10038473" cy="3985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22521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9E87978-8723-22BF-FC08-BF6F7F299DCB}"/>
              </a:ext>
            </a:extLst>
          </p:cNvPr>
          <p:cNvSpPr txBox="1"/>
          <p:nvPr/>
        </p:nvSpPr>
        <p:spPr>
          <a:xfrm>
            <a:off x="146372" y="5103674"/>
            <a:ext cx="1160366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t"/>
            <a:r>
              <a:rPr lang="en-US" b="1" dirty="0">
                <a:latin typeface="Aptos" panose="020B0004020202020204" pitchFamily="34" charset="0"/>
              </a:rPr>
              <a:t>Figure S5: Urine Iron and Plasma Heme Content</a:t>
            </a:r>
            <a:r>
              <a:rPr lang="en-US" dirty="0">
                <a:solidFill>
                  <a:srgbClr val="000000"/>
                </a:solidFill>
                <a:latin typeface="Aptos" panose="020B0004020202020204" pitchFamily="34" charset="0"/>
              </a:rPr>
              <a:t>. Plasma heme levels were significantly elevated in Hb-exposed males compared to females in the estrous phase, indicating reduced circulating heme in estrous females. Non-estrous females showed intermediate heme levels. Urinary iron levels showed a trend toward lower iron in estrous females compared to non-estrous females, though no significant differences were observed across groups.</a:t>
            </a:r>
          </a:p>
          <a:p>
            <a:pPr marL="0" algn="l" rtl="0" eaLnBrk="1" fontAlgn="t" latinLnBrk="0" hangingPunct="1"/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Statistical significance (p &lt; 0.05) between experimental groups is marked by * and compared to the control group is indicated by † .</a:t>
            </a:r>
            <a:endParaRPr lang="en-US" b="1" dirty="0">
              <a:latin typeface="Aptos" panose="020B00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83AC8B6-5D8A-EBDC-D38A-EE19D92E54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8166" y="314346"/>
            <a:ext cx="5720080" cy="4749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3819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91</TotalTime>
  <Words>488</Words>
  <Application>Microsoft Office PowerPoint</Application>
  <PresentationFormat>Widescreen</PresentationFormat>
  <Paragraphs>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-webkit-standar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x-Specific Acute Changes in Glomerular Filtration Rate in Response to Hemoglobin Exposure</dc:title>
  <dc:creator>Lucas, Daniela</dc:creator>
  <cp:lastModifiedBy>Amit Kumar1</cp:lastModifiedBy>
  <cp:revision>35</cp:revision>
  <dcterms:created xsi:type="dcterms:W3CDTF">2025-02-06T20:27:48Z</dcterms:created>
  <dcterms:modified xsi:type="dcterms:W3CDTF">2025-08-11T07:17:57Z</dcterms:modified>
</cp:coreProperties>
</file>